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67" r:id="rId3"/>
    <p:sldId id="274" r:id="rId4"/>
    <p:sldId id="278" r:id="rId5"/>
    <p:sldId id="282" r:id="rId6"/>
    <p:sldId id="285" r:id="rId7"/>
    <p:sldId id="288" r:id="rId8"/>
    <p:sldId id="292" r:id="rId9"/>
    <p:sldId id="294" r:id="rId10"/>
    <p:sldId id="295" r:id="rId11"/>
    <p:sldId id="298" r:id="rId12"/>
    <p:sldId id="277" r:id="rId13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0F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61BDF0-0B09-AD95-8536-DE5185B37A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43AD8E87-B311-F17A-A739-E6F8B10969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54BEA94-7954-7ED4-5B64-45C181FBD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55D2BDB-E98B-5B1A-A1A0-8A01F07CA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C1637FF-8B58-F867-70B9-753753DDA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8793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CEFCCA-0041-9953-0515-2641AEE7C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65ADB039-4776-27B2-1441-697B85E525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D0D209D-8881-302F-8BAD-E5D36B01D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9B4AE9B-F27F-F35B-6EF1-0CCD336EA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45ADDFA-FB07-E094-FCAE-F4BF22822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68400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4B98C90-8F36-E9CF-74D1-ECF5CADCC1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FDF5FBB-90C7-EF79-8FB3-10878BB1A9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76E86CB-727F-13D4-7AC5-55D3964B5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1878430-EEF3-4168-D6CA-047DE1459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C917F3C-09EC-FDC1-6AA6-4A31333BB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33934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1C74C4-EFD4-5173-616D-B436CE55C3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9F4322-9327-6FB1-4138-117D81BB72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1C6E32D-D09E-0EC0-D361-9FA7678AD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D724383-A382-4C66-363E-66808D1E4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B3ACE3D-5057-B61D-B59E-EBBFFACB6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00563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7EAC76-FAA8-1B71-3E9B-ECA95427D7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DAE08A7-C89C-5CCB-8860-8A827AF8E7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28B178A-5B69-9655-071B-6849F2E6A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EFC3099-5E5A-9F8E-1BAB-037F00541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5653FFD-E5B5-868D-16E5-BAAF78AAB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36241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98412D4-C307-A6F1-3851-30E500FF1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DD8CCAD4-8F34-2266-6EE8-934CEC5CB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537FA9B8-40CB-4757-04EC-9E51C2CEFC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6AC1BEA-B5B9-D8CB-9C80-5B4DDF0A2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2768E5B-9569-F4A1-340B-EB6CD1C4B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A670BAC-B238-AECC-DD21-F4CA61345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68216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F547CE-E4FF-84AD-F4EE-D2AA28A27B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4DF31FF-680D-E4C6-E4CC-84CCEB6E83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7B55331D-9244-F052-E754-6A495EFA8A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0AC0406E-A3E3-8163-7AA8-B3104C20AD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6D199407-F19B-14F3-B881-2FBD097F83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B4598059-0F65-287D-7F6B-A0C6E9D09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A723EFCD-2BF0-58C4-1ED7-8AF52647A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1888F4A5-D9F4-0256-2501-195259828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87726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564578-1BD8-4AC9-BDFB-13BB18FC38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8B48EDE3-A3CA-BBF9-EBEE-4C9F8B59F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E3F2AEE2-7FBA-08A8-716B-FD01D0C69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EE9B7E62-6059-BB71-01D3-4BC22EA50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73384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4692E51F-39CA-C9A9-EA74-BD0B1ADE8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76834F57-ED9E-892C-53ED-26F4619D5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1BDA088-2B1A-2DEA-5C4A-3837DDAC1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01470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A8CA4B-C9B6-B3D2-66C3-EA6450597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3082E6C-9225-1192-0D30-E85D83163E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E5CED19-7A10-2100-D400-D652F1BBC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1097811-6CB0-3771-7FF1-BD16C2EBA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CB0068DD-F3BF-57AF-4749-393D7A48F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3020F3D4-BCE3-7CA2-0B41-E4CBC3913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9207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ED4A20-EBD1-997F-34DC-A1535E4E1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CE71273-074D-4C20-403E-F4353751E6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DD3A94E-B0C3-E474-3809-0388C27E4C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CFBC969F-79FA-3994-6142-C01507133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EC2F909-8475-64CB-992F-3755F57C1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EC32468-B747-46EE-60B1-D06DC2B84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133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6A510EC9-43A9-82C9-BE45-40CB95CEE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89EC5C8-9C95-8024-5C84-2171589372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43F824E-EAA3-06E1-5B09-A06DA06A1F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92CC47-A87C-4D23-A86D-0729B7ADF448}" type="datetimeFigureOut">
              <a:rPr lang="pt-BR" smtClean="0"/>
              <a:t>07/0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4FB289A-1436-7024-45EE-786348BA42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C135721-7A54-FE72-E56A-8DF80303B1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B19AAC-1698-4452-B799-D05F167DB97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23731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m 15">
            <a:extLst>
              <a:ext uri="{FF2B5EF4-FFF2-40B4-BE49-F238E27FC236}">
                <a16:creationId xmlns:a16="http://schemas.microsoft.com/office/drawing/2014/main" id="{0812CA7D-4D14-102E-3689-037BF458B6DE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62220" t="23717" r="2832" b="32206"/>
          <a:stretch/>
        </p:blipFill>
        <p:spPr>
          <a:xfrm>
            <a:off x="-108933" y="-27031"/>
            <a:ext cx="2099779" cy="1884873"/>
          </a:xfrm>
          <a:prstGeom prst="rect">
            <a:avLst/>
          </a:prstGeom>
        </p:spPr>
      </p:pic>
      <p:pic>
        <p:nvPicPr>
          <p:cNvPr id="13" name="Imagem 12">
            <a:extLst>
              <a:ext uri="{FF2B5EF4-FFF2-40B4-BE49-F238E27FC236}">
                <a16:creationId xmlns:a16="http://schemas.microsoft.com/office/drawing/2014/main" id="{EFABC4CB-DD59-32CC-C8A9-DF4A34602D27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-312492" y="4260635"/>
            <a:ext cx="2364884" cy="2597365"/>
          </a:xfrm>
          <a:prstGeom prst="rect">
            <a:avLst/>
          </a:prstGeom>
        </p:spPr>
      </p:pic>
      <p:pic>
        <p:nvPicPr>
          <p:cNvPr id="11" name="Imagem 10">
            <a:extLst>
              <a:ext uri="{FF2B5EF4-FFF2-40B4-BE49-F238E27FC236}">
                <a16:creationId xmlns:a16="http://schemas.microsoft.com/office/drawing/2014/main" id="{FE4D4101-E602-5CEC-CDC8-EE0BA713F089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 rot="1292016">
            <a:off x="10294320" y="-259703"/>
            <a:ext cx="1973142" cy="2232117"/>
          </a:xfrm>
          <a:prstGeom prst="rect">
            <a:avLst/>
          </a:prstGeom>
        </p:spPr>
      </p:pic>
      <p:sp>
        <p:nvSpPr>
          <p:cNvPr id="4" name="Retângulo 3">
            <a:extLst>
              <a:ext uri="{FF2B5EF4-FFF2-40B4-BE49-F238E27FC236}">
                <a16:creationId xmlns:a16="http://schemas.microsoft.com/office/drawing/2014/main" id="{50970874-1214-FC80-F796-C7FA7C5A1355}"/>
              </a:ext>
            </a:extLst>
          </p:cNvPr>
          <p:cNvSpPr/>
          <p:nvPr/>
        </p:nvSpPr>
        <p:spPr>
          <a:xfrm>
            <a:off x="250724" y="162230"/>
            <a:ext cx="11739716" cy="6445045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61D141E8-D822-EB07-D5EF-311DE551D66C}"/>
              </a:ext>
            </a:extLst>
          </p:cNvPr>
          <p:cNvSpPr txBox="1"/>
          <p:nvPr/>
        </p:nvSpPr>
        <p:spPr>
          <a:xfrm>
            <a:off x="869950" y="2486157"/>
            <a:ext cx="10452100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pt-BR" sz="3800" b="1" i="1" u="sng" dirty="0" err="1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Interactive</a:t>
            </a:r>
            <a:r>
              <a:rPr lang="pt-BR" sz="3800" b="1" i="1" u="sng" dirty="0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 </a:t>
            </a:r>
            <a:r>
              <a:rPr lang="pt-BR" sz="3800" b="1" i="1" u="sng" dirty="0" err="1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Bioinformatics</a:t>
            </a:r>
            <a:r>
              <a:rPr lang="pt-BR" sz="3800" b="1" i="1" u="sng" dirty="0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 </a:t>
            </a:r>
            <a:r>
              <a:rPr lang="pt-BR" sz="3800" b="1" i="1" u="sng" dirty="0" err="1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Introduction</a:t>
            </a:r>
            <a:r>
              <a:rPr lang="pt-BR" sz="3800" b="1" i="1" u="sng" dirty="0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 </a:t>
            </a:r>
            <a:r>
              <a:rPr lang="pt-BR" sz="3800" b="1" i="1" u="sng" dirty="0" err="1">
                <a:solidFill>
                  <a:srgbClr val="C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genial" panose="02000503040000020004" pitchFamily="2" charset="0"/>
              </a:rPr>
              <a:t>Lab</a:t>
            </a:r>
            <a:endParaRPr lang="pt-BR" sz="3800" b="1" i="1" u="sng" dirty="0">
              <a:solidFill>
                <a:srgbClr val="C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Congenial" panose="02000503040000020004" pitchFamily="2" charset="0"/>
            </a:endParaRPr>
          </a:p>
        </p:txBody>
      </p:sp>
      <p:pic>
        <p:nvPicPr>
          <p:cNvPr id="20" name="Imagem 19">
            <a:extLst>
              <a:ext uri="{FF2B5EF4-FFF2-40B4-BE49-F238E27FC236}">
                <a16:creationId xmlns:a16="http://schemas.microsoft.com/office/drawing/2014/main" id="{7A72E8FA-2F1E-7DC6-234F-013E64F572B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31298" r="4894" b="50898"/>
          <a:stretch/>
        </p:blipFill>
        <p:spPr>
          <a:xfrm>
            <a:off x="2923699" y="335173"/>
            <a:ext cx="6583369" cy="919974"/>
          </a:xfrm>
          <a:prstGeom prst="rect">
            <a:avLst/>
          </a:prstGeo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A1490DEF-A7BE-3916-7ECE-83FC725870D2}"/>
              </a:ext>
            </a:extLst>
          </p:cNvPr>
          <p:cNvSpPr txBox="1"/>
          <p:nvPr/>
        </p:nvSpPr>
        <p:spPr>
          <a:xfrm flipH="1">
            <a:off x="2615608" y="3208429"/>
            <a:ext cx="8084085" cy="2603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pt-BR" sz="2400" dirty="0" err="1"/>
              <a:t>Name</a:t>
            </a:r>
            <a:r>
              <a:rPr lang="pt-BR" sz="2400" dirty="0"/>
              <a:t>: ___________________________________________</a:t>
            </a:r>
          </a:p>
          <a:p>
            <a:pPr>
              <a:lnSpc>
                <a:spcPct val="200000"/>
              </a:lnSpc>
            </a:pPr>
            <a:r>
              <a:rPr lang="pt-BR" sz="2400" dirty="0" err="1"/>
              <a:t>Chosen</a:t>
            </a:r>
            <a:r>
              <a:rPr lang="pt-BR" sz="2400" dirty="0"/>
              <a:t> Gene: ____________________</a:t>
            </a:r>
          </a:p>
          <a:p>
            <a:pPr>
              <a:lnSpc>
                <a:spcPct val="200000"/>
              </a:lnSpc>
            </a:pPr>
            <a:r>
              <a:rPr lang="pt-BR" dirty="0" err="1"/>
              <a:t>Reason</a:t>
            </a:r>
            <a:r>
              <a:rPr lang="pt-BR" dirty="0"/>
              <a:t>(s) for </a:t>
            </a:r>
            <a:r>
              <a:rPr lang="pt-BR" dirty="0" err="1"/>
              <a:t>this</a:t>
            </a:r>
            <a:r>
              <a:rPr lang="pt-BR" dirty="0"/>
              <a:t> </a:t>
            </a:r>
            <a:r>
              <a:rPr lang="pt-BR" dirty="0" err="1"/>
              <a:t>choice</a:t>
            </a:r>
            <a:r>
              <a:rPr lang="pt-BR" dirty="0"/>
              <a:t>:__________________________________________________</a:t>
            </a:r>
          </a:p>
          <a:p>
            <a:pPr>
              <a:lnSpc>
                <a:spcPct val="200000"/>
              </a:lnSpc>
            </a:pPr>
            <a:r>
              <a:rPr lang="pt-BR" dirty="0"/>
              <a:t>__________________________________________________________________________</a:t>
            </a:r>
          </a:p>
        </p:txBody>
      </p:sp>
    </p:spTree>
    <p:extLst>
      <p:ext uri="{BB962C8B-B14F-4D97-AF65-F5344CB8AC3E}">
        <p14:creationId xmlns:p14="http://schemas.microsoft.com/office/powerpoint/2010/main" val="18542678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354826B-99DB-9624-67A8-B2AB212114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>
            <a:extLst>
              <a:ext uri="{FF2B5EF4-FFF2-40B4-BE49-F238E27FC236}">
                <a16:creationId xmlns:a16="http://schemas.microsoft.com/office/drawing/2014/main" id="{6217B091-48A6-A2A3-7F41-855CA4F91369}"/>
              </a:ext>
            </a:extLst>
          </p:cNvPr>
          <p:cNvSpPr/>
          <p:nvPr/>
        </p:nvSpPr>
        <p:spPr>
          <a:xfrm>
            <a:off x="10210800" y="5562600"/>
            <a:ext cx="1524000" cy="8636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8AFD76DC-8D87-B359-FB09-83182C8E1C11}"/>
              </a:ext>
            </a:extLst>
          </p:cNvPr>
          <p:cNvSpPr txBox="1"/>
          <p:nvPr/>
        </p:nvSpPr>
        <p:spPr>
          <a:xfrm>
            <a:off x="232017" y="4835565"/>
            <a:ext cx="11729955" cy="1754326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How does </a:t>
            </a:r>
            <a:r>
              <a:rPr lang="en-US" b="1" dirty="0" err="1"/>
              <a:t>GeneCards</a:t>
            </a:r>
            <a:r>
              <a:rPr lang="en-US" b="1" dirty="0"/>
              <a:t>, by consolidating information from various databases, improve our ability to study genes in a more integrated and comprehensive manner, especially in relation to drug development and disease mechanisms?</a:t>
            </a:r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pPr algn="just"/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pPr algn="just"/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pPr algn="just"/>
            <a:endParaRPr lang="pt-BR" b="1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E8499C4E-BBAB-FD6F-17A1-D2313A807CBF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EE7812F7-0FEC-540D-999A-33BA1C52CF6E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9E8E6B52-A7C8-D405-D96C-453680C807C3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9</a:t>
            </a:r>
          </a:p>
        </p:txBody>
      </p:sp>
    </p:spTree>
    <p:extLst>
      <p:ext uri="{BB962C8B-B14F-4D97-AF65-F5344CB8AC3E}">
        <p14:creationId xmlns:p14="http://schemas.microsoft.com/office/powerpoint/2010/main" val="27665371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6932B3-5750-FECA-CD2C-3DDE3AE7C4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>
            <a:extLst>
              <a:ext uri="{FF2B5EF4-FFF2-40B4-BE49-F238E27FC236}">
                <a16:creationId xmlns:a16="http://schemas.microsoft.com/office/drawing/2014/main" id="{38C6888E-2A86-D99D-F88C-5E983B8EBC90}"/>
              </a:ext>
            </a:extLst>
          </p:cNvPr>
          <p:cNvSpPr/>
          <p:nvPr/>
        </p:nvSpPr>
        <p:spPr>
          <a:xfrm>
            <a:off x="10210800" y="5562600"/>
            <a:ext cx="1524000" cy="8636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F1B36411-E377-1974-494F-B1010CC6E3DD}"/>
              </a:ext>
            </a:extLst>
          </p:cNvPr>
          <p:cNvSpPr txBox="1"/>
          <p:nvPr/>
        </p:nvSpPr>
        <p:spPr>
          <a:xfrm>
            <a:off x="220473" y="5384919"/>
            <a:ext cx="11751054" cy="1200329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ptos Narrow" panose="020B0004020202020204" pitchFamily="34" charset="0"/>
                <a:ea typeface="Aptos" panose="020B0004020202020204" pitchFamily="34" charset="0"/>
              </a:rPr>
              <a:t>How can databases specialized in genetic variants, such as </a:t>
            </a:r>
            <a:r>
              <a:rPr lang="en-US" b="1" dirty="0" err="1">
                <a:latin typeface="Aptos Narrow" panose="020B0004020202020204" pitchFamily="34" charset="0"/>
                <a:ea typeface="Aptos" panose="020B0004020202020204" pitchFamily="34" charset="0"/>
              </a:rPr>
              <a:t>ClinVar</a:t>
            </a:r>
            <a:r>
              <a:rPr lang="en-US" b="1" dirty="0">
                <a:latin typeface="Aptos Narrow" panose="020B0004020202020204" pitchFamily="34" charset="0"/>
                <a:ea typeface="Aptos" panose="020B0004020202020204" pitchFamily="34" charset="0"/>
              </a:rPr>
              <a:t>, </a:t>
            </a:r>
            <a:r>
              <a:rPr lang="en-US" b="1" dirty="0" err="1">
                <a:latin typeface="Aptos Narrow" panose="020B0004020202020204" pitchFamily="34" charset="0"/>
                <a:ea typeface="Aptos" panose="020B0004020202020204" pitchFamily="34" charset="0"/>
              </a:rPr>
              <a:t>PharmGKB</a:t>
            </a:r>
            <a:r>
              <a:rPr lang="en-US" b="1" dirty="0">
                <a:latin typeface="Aptos Narrow" panose="020B0004020202020204" pitchFamily="34" charset="0"/>
                <a:ea typeface="Aptos" panose="020B0004020202020204" pitchFamily="34" charset="0"/>
              </a:rPr>
              <a:t> and others, contribute to understanding the clinical and functional impacts of genetic variants, and what is their role in advancing personalized medicine?</a:t>
            </a: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D2F38476-D291-3A63-E73F-6BCCD15F8DC5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CFC96031-730D-F954-38A5-2AFC43F4B729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D3002CC7-1102-E51F-9D89-5DD5E0C8276F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10</a:t>
            </a:r>
            <a:endParaRPr lang="pt-BR" b="1" dirty="0">
              <a:solidFill>
                <a:schemeClr val="tx1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9564272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D82AB6-375B-881D-311B-662051BE57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>
            <a:extLst>
              <a:ext uri="{FF2B5EF4-FFF2-40B4-BE49-F238E27FC236}">
                <a16:creationId xmlns:a16="http://schemas.microsoft.com/office/drawing/2014/main" id="{6E823749-47FC-E8A9-6901-DA971A51F814}"/>
              </a:ext>
            </a:extLst>
          </p:cNvPr>
          <p:cNvSpPr/>
          <p:nvPr/>
        </p:nvSpPr>
        <p:spPr>
          <a:xfrm>
            <a:off x="122832" y="206477"/>
            <a:ext cx="11965858" cy="6445045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993B188A-D853-BA3E-DF07-7D9E3E936C6A}"/>
              </a:ext>
            </a:extLst>
          </p:cNvPr>
          <p:cNvSpPr/>
          <p:nvPr/>
        </p:nvSpPr>
        <p:spPr>
          <a:xfrm>
            <a:off x="375674" y="29496"/>
            <a:ext cx="1862559" cy="430887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800" b="1" dirty="0" err="1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Final_Questions</a:t>
            </a:r>
            <a:endParaRPr lang="pt-BR" b="1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2C60BD28-794E-1B9A-F28A-55A041974999}"/>
              </a:ext>
            </a:extLst>
          </p:cNvPr>
          <p:cNvSpPr txBox="1"/>
          <p:nvPr/>
        </p:nvSpPr>
        <p:spPr>
          <a:xfrm>
            <a:off x="375674" y="546471"/>
            <a:ext cx="11132464" cy="43088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pt-BR" sz="2200" b="1" dirty="0">
                <a:latin typeface="+mj-lt"/>
              </a:rPr>
              <a:t>1) </a:t>
            </a:r>
            <a:r>
              <a:rPr lang="pt-BR" sz="2200" b="1" dirty="0" err="1">
                <a:latin typeface="+mj-lt"/>
              </a:rPr>
              <a:t>How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this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activity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have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impacted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your</a:t>
            </a:r>
            <a:r>
              <a:rPr lang="pt-BR" sz="2200" b="1" dirty="0">
                <a:latin typeface="+mj-lt"/>
              </a:rPr>
              <a:t> learning </a:t>
            </a:r>
            <a:r>
              <a:rPr lang="pt-BR" sz="2200" b="1" dirty="0" err="1">
                <a:latin typeface="+mj-lt"/>
              </a:rPr>
              <a:t>and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how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can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you</a:t>
            </a:r>
            <a:r>
              <a:rPr lang="pt-BR" sz="2200" b="1" dirty="0">
                <a:latin typeface="+mj-lt"/>
              </a:rPr>
              <a:t> use in </a:t>
            </a:r>
            <a:r>
              <a:rPr lang="pt-BR" sz="2200" b="1" dirty="0" err="1">
                <a:latin typeface="+mj-lt"/>
              </a:rPr>
              <a:t>your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studies</a:t>
            </a:r>
            <a:r>
              <a:rPr lang="pt-BR" sz="2200" b="1" dirty="0">
                <a:latin typeface="+mj-lt"/>
              </a:rPr>
              <a:t> ? 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A0CD2DBE-5349-B461-77DE-40BB9AE86D99}"/>
              </a:ext>
            </a:extLst>
          </p:cNvPr>
          <p:cNvSpPr txBox="1"/>
          <p:nvPr/>
        </p:nvSpPr>
        <p:spPr>
          <a:xfrm>
            <a:off x="176905" y="1095631"/>
            <a:ext cx="11864967" cy="2585323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Writing critical comments:</a:t>
            </a: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AC6511E9-6D1E-E522-7951-E78C13187253}"/>
              </a:ext>
            </a:extLst>
          </p:cNvPr>
          <p:cNvSpPr txBox="1"/>
          <p:nvPr/>
        </p:nvSpPr>
        <p:spPr>
          <a:xfrm>
            <a:off x="375674" y="3723628"/>
            <a:ext cx="11132464" cy="43088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pt-BR" sz="2200" b="1" dirty="0">
                <a:latin typeface="+mj-lt"/>
              </a:rPr>
              <a:t>2) </a:t>
            </a:r>
            <a:r>
              <a:rPr lang="pt-BR" sz="2200" b="1" dirty="0" err="1">
                <a:latin typeface="+mj-lt"/>
              </a:rPr>
              <a:t>There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were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dificulties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to</a:t>
            </a:r>
            <a:r>
              <a:rPr lang="pt-BR" sz="2200" b="1" dirty="0">
                <a:latin typeface="+mj-lt"/>
              </a:rPr>
              <a:t> execute </a:t>
            </a:r>
            <a:r>
              <a:rPr lang="pt-BR" sz="2200" b="1" dirty="0" err="1">
                <a:latin typeface="+mj-lt"/>
              </a:rPr>
              <a:t>this</a:t>
            </a:r>
            <a:r>
              <a:rPr lang="pt-BR" sz="2200" b="1" dirty="0">
                <a:latin typeface="+mj-lt"/>
              </a:rPr>
              <a:t> </a:t>
            </a:r>
            <a:r>
              <a:rPr lang="pt-BR" sz="2200" b="1" dirty="0" err="1">
                <a:latin typeface="+mj-lt"/>
              </a:rPr>
              <a:t>activity</a:t>
            </a:r>
            <a:r>
              <a:rPr lang="pt-BR" sz="2200" b="1" dirty="0">
                <a:latin typeface="+mj-lt"/>
              </a:rPr>
              <a:t> ?  </a:t>
            </a:r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112E9AD4-431C-21A7-23E5-A1821ADF8414}"/>
              </a:ext>
            </a:extLst>
          </p:cNvPr>
          <p:cNvSpPr txBox="1"/>
          <p:nvPr/>
        </p:nvSpPr>
        <p:spPr>
          <a:xfrm>
            <a:off x="179578" y="4269003"/>
            <a:ext cx="11862294" cy="2308324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Writing critical comments:</a:t>
            </a:r>
          </a:p>
          <a:p>
            <a:pPr algn="just"/>
            <a:r>
              <a:rPr lang="en-US" dirty="0">
                <a:latin typeface="Aptos Narrow" panose="020B0004020202020204" pitchFamily="34" charset="0"/>
                <a:ea typeface="Aptos" panose="020B0004020202020204" pitchFamily="34" charset="0"/>
              </a:rPr>
              <a:t>	</a:t>
            </a:r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8426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568C66-D753-7630-9539-1C7103356C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0D11DD6B-43BE-FFDE-B885-F590D69DDFB4}"/>
              </a:ext>
            </a:extLst>
          </p:cNvPr>
          <p:cNvSpPr txBox="1"/>
          <p:nvPr/>
        </p:nvSpPr>
        <p:spPr>
          <a:xfrm>
            <a:off x="239195" y="4921189"/>
            <a:ext cx="11702595" cy="1723549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7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Write comments about the more relevant aspects presented in the Abstract of the paper above, and after, your personal critical comments/perceptions about that study:</a:t>
            </a: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C51C9884-E007-DC97-F814-A6C326C7E3C9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AE37B57C-AB1F-5B2F-9A1F-103E8C5A492E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08756CC4-5EF0-1F81-1FB4-AB33C4DA6ADC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1</a:t>
            </a:r>
          </a:p>
        </p:txBody>
      </p:sp>
    </p:spTree>
    <p:extLst>
      <p:ext uri="{BB962C8B-B14F-4D97-AF65-F5344CB8AC3E}">
        <p14:creationId xmlns:p14="http://schemas.microsoft.com/office/powerpoint/2010/main" val="220488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8CE51E-0C07-D79D-8458-5F1AE75F75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>
            <a:extLst>
              <a:ext uri="{FF2B5EF4-FFF2-40B4-BE49-F238E27FC236}">
                <a16:creationId xmlns:a16="http://schemas.microsoft.com/office/drawing/2014/main" id="{AF93065A-02DF-A958-ED87-DAF4F2F460A1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2594913A-D4D7-4B15-92E0-C06B40FB95B6}"/>
              </a:ext>
            </a:extLst>
          </p:cNvPr>
          <p:cNvSpPr txBox="1"/>
          <p:nvPr/>
        </p:nvSpPr>
        <p:spPr>
          <a:xfrm>
            <a:off x="193488" y="5262347"/>
            <a:ext cx="11802379" cy="1384995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How many base pairs has the gene? </a:t>
            </a:r>
          </a:p>
          <a:p>
            <a:pPr algn="just"/>
            <a:r>
              <a:rPr lang="en-US" sz="12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(Ex: 8690) Copy and paste the mRNA numbers (Ex: </a:t>
            </a:r>
            <a:r>
              <a:rPr lang="fi-FI" sz="12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join(1..197,471..518,3793..3893,5726..5902,8498..8690) and answer if it agrees with the number of exons.</a:t>
            </a:r>
            <a:endParaRPr lang="en-US" sz="12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4474AE8A-E1B6-D63A-9F29-4CD5CC23F66A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BF0EDB9A-3319-9A6D-73B1-D60BE4134278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2</a:t>
            </a:r>
          </a:p>
        </p:txBody>
      </p:sp>
    </p:spTree>
    <p:extLst>
      <p:ext uri="{BB962C8B-B14F-4D97-AF65-F5344CB8AC3E}">
        <p14:creationId xmlns:p14="http://schemas.microsoft.com/office/powerpoint/2010/main" val="2497771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FF471C-EEFC-BF0D-00F6-6A335953668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ângulo 1">
            <a:extLst>
              <a:ext uri="{FF2B5EF4-FFF2-40B4-BE49-F238E27FC236}">
                <a16:creationId xmlns:a16="http://schemas.microsoft.com/office/drawing/2014/main" id="{501E328D-2902-18FE-FE99-1128C719A1AB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6" name="Retângulo 15">
            <a:extLst>
              <a:ext uri="{FF2B5EF4-FFF2-40B4-BE49-F238E27FC236}">
                <a16:creationId xmlns:a16="http://schemas.microsoft.com/office/drawing/2014/main" id="{317234B0-12D8-09CD-C8D1-C1B7F86718C9}"/>
              </a:ext>
            </a:extLst>
          </p:cNvPr>
          <p:cNvSpPr/>
          <p:nvPr/>
        </p:nvSpPr>
        <p:spPr>
          <a:xfrm>
            <a:off x="7912100" y="3135942"/>
            <a:ext cx="1981200" cy="364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8" name="Retângulo 17">
            <a:extLst>
              <a:ext uri="{FF2B5EF4-FFF2-40B4-BE49-F238E27FC236}">
                <a16:creationId xmlns:a16="http://schemas.microsoft.com/office/drawing/2014/main" id="{E8278C27-A60A-63A4-4122-F042C5DE8259}"/>
              </a:ext>
            </a:extLst>
          </p:cNvPr>
          <p:cNvSpPr/>
          <p:nvPr/>
        </p:nvSpPr>
        <p:spPr>
          <a:xfrm>
            <a:off x="2369165" y="5024241"/>
            <a:ext cx="1847235" cy="1634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147F3534-C4E8-159B-5793-0D4CAEC2892C}"/>
              </a:ext>
            </a:extLst>
          </p:cNvPr>
          <p:cNvSpPr txBox="1"/>
          <p:nvPr/>
        </p:nvSpPr>
        <p:spPr>
          <a:xfrm>
            <a:off x="258319" y="5193858"/>
            <a:ext cx="11729954" cy="141577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Where can I view the amino acid sequence of a specific protein, and what is the total number of amino acids in that sequence?</a:t>
            </a:r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C03D29D9-E8BA-F20A-C3F4-5EEB7945D8D7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404E0B96-489C-171A-69BC-996F1DB1F5DE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3</a:t>
            </a:r>
          </a:p>
        </p:txBody>
      </p:sp>
    </p:spTree>
    <p:extLst>
      <p:ext uri="{BB962C8B-B14F-4D97-AF65-F5344CB8AC3E}">
        <p14:creationId xmlns:p14="http://schemas.microsoft.com/office/powerpoint/2010/main" val="34283453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8735BF-8D16-66D5-520A-1C008DE170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927172C4-3C5D-27F8-62F6-5C00CACD8CDE}"/>
              </a:ext>
            </a:extLst>
          </p:cNvPr>
          <p:cNvSpPr txBox="1"/>
          <p:nvPr/>
        </p:nvSpPr>
        <p:spPr>
          <a:xfrm>
            <a:off x="186776" y="5164408"/>
            <a:ext cx="11818448" cy="147732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What types of genetic data does the NCBI offer and how can they be used for bioinformatics research?</a:t>
            </a:r>
          </a:p>
          <a:p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CE48A556-5102-1183-FA6B-90984FE2612D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D9CA208F-21E1-3855-AFF2-2F9B8A8E0A0D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67ABE7BC-D243-0FD7-A455-E27D2C1A0E17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4</a:t>
            </a:r>
          </a:p>
        </p:txBody>
      </p:sp>
    </p:spTree>
    <p:extLst>
      <p:ext uri="{BB962C8B-B14F-4D97-AF65-F5344CB8AC3E}">
        <p14:creationId xmlns:p14="http://schemas.microsoft.com/office/powerpoint/2010/main" val="3814689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2CBA0C-BF6B-651A-0846-21D886E9B7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tângulo 6">
            <a:extLst>
              <a:ext uri="{FF2B5EF4-FFF2-40B4-BE49-F238E27FC236}">
                <a16:creationId xmlns:a16="http://schemas.microsoft.com/office/drawing/2014/main" id="{67E9460B-E8F7-E611-741D-2AB84C003390}"/>
              </a:ext>
            </a:extLst>
          </p:cNvPr>
          <p:cNvSpPr/>
          <p:nvPr/>
        </p:nvSpPr>
        <p:spPr>
          <a:xfrm>
            <a:off x="9918700" y="5562554"/>
            <a:ext cx="1473200" cy="812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CDD77DA2-0A0F-4B27-9F97-9F9089288BC5}"/>
              </a:ext>
            </a:extLst>
          </p:cNvPr>
          <p:cNvSpPr txBox="1"/>
          <p:nvPr/>
        </p:nvSpPr>
        <p:spPr>
          <a:xfrm>
            <a:off x="220473" y="5155643"/>
            <a:ext cx="11751054" cy="147732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How can the </a:t>
            </a:r>
            <a:r>
              <a:rPr lang="en-US" sz="1800" b="1" dirty="0" err="1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dbSNP</a:t>
            </a:r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and OMIM databases help researchers understand the genetic variation and clinical implications of specific genes like IL4?</a:t>
            </a: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pPr algn="just"/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0F4A7A0F-893B-23C0-4723-DA380EA86B8E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86EFB834-6721-AB2C-3E1F-6ABB376D1BDE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F689A493-B3D3-02B4-046F-FDD068C3F850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5</a:t>
            </a:r>
          </a:p>
        </p:txBody>
      </p:sp>
    </p:spTree>
    <p:extLst>
      <p:ext uri="{BB962C8B-B14F-4D97-AF65-F5344CB8AC3E}">
        <p14:creationId xmlns:p14="http://schemas.microsoft.com/office/powerpoint/2010/main" val="39469860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55576B-1132-CA69-1AE7-8DBA7F4C2D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7922FF55-69FE-615E-FF1C-D06D4782F24D}"/>
              </a:ext>
            </a:extLst>
          </p:cNvPr>
          <p:cNvSpPr txBox="1"/>
          <p:nvPr/>
        </p:nvSpPr>
        <p:spPr>
          <a:xfrm>
            <a:off x="292178" y="5156979"/>
            <a:ext cx="11662745" cy="147732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How do the detailed genomic, mRNA, and protein sequence data provided by </a:t>
            </a:r>
            <a:r>
              <a:rPr lang="en-US" b="1" dirty="0" err="1"/>
              <a:t>Ensembl</a:t>
            </a:r>
            <a:r>
              <a:rPr lang="en-US" b="1" dirty="0"/>
              <a:t> enhance our understanding of gene function and its potential role in diseases?</a:t>
            </a:r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pPr algn="just"/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pPr algn="just"/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pPr algn="just"/>
            <a:endParaRPr lang="pt-BR" b="1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5C23B5A5-A31A-2000-6169-FB9F71F1E279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9F7AD4FD-6ACD-A03F-2BB9-CFC89312EA74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21D5E39A-42C1-3DC7-3DB5-E7C3C99AB009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6</a:t>
            </a:r>
          </a:p>
        </p:txBody>
      </p:sp>
    </p:spTree>
    <p:extLst>
      <p:ext uri="{BB962C8B-B14F-4D97-AF65-F5344CB8AC3E}">
        <p14:creationId xmlns:p14="http://schemas.microsoft.com/office/powerpoint/2010/main" val="1953186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FA2AB7-8291-CC64-A03B-A4EF477285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17604CAF-2013-822C-F69F-53EEA85CC628}"/>
              </a:ext>
            </a:extLst>
          </p:cNvPr>
          <p:cNvSpPr txBox="1"/>
          <p:nvPr/>
        </p:nvSpPr>
        <p:spPr>
          <a:xfrm>
            <a:off x="218369" y="5075356"/>
            <a:ext cx="11791145" cy="147732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How do the visual representations of aligned and color-coded sequences in </a:t>
            </a:r>
            <a:r>
              <a:rPr lang="en-US" b="1" dirty="0" err="1"/>
              <a:t>Ensembl</a:t>
            </a:r>
            <a:r>
              <a:rPr lang="en-US" b="1" dirty="0"/>
              <a:t> help in identifying and understanding the impact of polymorphisms and mutations on gene function?</a:t>
            </a:r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F8D8E517-6A6C-8EAA-2D05-EA25D3ED4538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8E76EF89-FA39-B359-CB4A-23DD413F0E9F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96929BA6-CE18-3C64-D69C-7E93D2B47DD8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7</a:t>
            </a:r>
          </a:p>
        </p:txBody>
      </p:sp>
    </p:spTree>
    <p:extLst>
      <p:ext uri="{BB962C8B-B14F-4D97-AF65-F5344CB8AC3E}">
        <p14:creationId xmlns:p14="http://schemas.microsoft.com/office/powerpoint/2010/main" val="13576893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7065F6-936C-0BC8-0987-CB16527362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658D202C-354A-B1C3-663B-9A9BA8992819}"/>
              </a:ext>
            </a:extLst>
          </p:cNvPr>
          <p:cNvSpPr txBox="1"/>
          <p:nvPr/>
        </p:nvSpPr>
        <p:spPr>
          <a:xfrm>
            <a:off x="259313" y="5103841"/>
            <a:ext cx="11695544" cy="1477328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How does the subcellular localization of a protein, as shown in </a:t>
            </a:r>
            <a:r>
              <a:rPr lang="en-US" b="1" dirty="0" err="1"/>
              <a:t>UniProt</a:t>
            </a:r>
            <a:r>
              <a:rPr lang="en-US" b="1" dirty="0"/>
              <a:t>, inform our understanding of its biological function and potential roles in cellular processes?</a:t>
            </a:r>
            <a:endParaRPr lang="en-US" sz="1800" b="1" dirty="0">
              <a:solidFill>
                <a:schemeClr val="tx1"/>
              </a:solidFill>
              <a:effectLst/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endParaRPr lang="en-US" b="1" dirty="0">
              <a:latin typeface="Aptos Narrow" panose="020B0004020202020204" pitchFamily="34" charset="0"/>
              <a:ea typeface="Aptos" panose="020B0004020202020204" pitchFamily="34" charset="0"/>
            </a:endParaRPr>
          </a:p>
          <a:p>
            <a:r>
              <a:rPr lang="en-US" sz="1800" b="1" dirty="0">
                <a:solidFill>
                  <a:schemeClr val="tx1"/>
                </a:solidFill>
                <a:effectLst/>
                <a:latin typeface="Aptos Narrow" panose="020B0004020202020204" pitchFamily="34" charset="0"/>
                <a:ea typeface="Aptos" panose="020B0004020202020204" pitchFamily="34" charset="0"/>
              </a:rPr>
              <a:t> </a:t>
            </a:r>
            <a:endParaRPr lang="pt-BR" b="1" dirty="0">
              <a:solidFill>
                <a:schemeClr val="tx1"/>
              </a:solidFill>
              <a:latin typeface="Aptos Narrow" panose="020B0004020202020204" pitchFamily="34" charset="0"/>
            </a:endParaRPr>
          </a:p>
          <a:p>
            <a:endParaRPr lang="pt-BR" dirty="0"/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9FF2FAD8-CB12-1E25-9896-EE9B0A327F16}"/>
              </a:ext>
            </a:extLst>
          </p:cNvPr>
          <p:cNvSpPr/>
          <p:nvPr/>
        </p:nvSpPr>
        <p:spPr>
          <a:xfrm>
            <a:off x="127892" y="162231"/>
            <a:ext cx="11941275" cy="6538820"/>
          </a:xfrm>
          <a:prstGeom prst="rect">
            <a:avLst/>
          </a:prstGeom>
          <a:noFill/>
          <a:ln>
            <a:prstDash val="dash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C2490051-6D48-C6C3-1800-19793DA104E0}"/>
              </a:ext>
            </a:extLst>
          </p:cNvPr>
          <p:cNvSpPr/>
          <p:nvPr/>
        </p:nvSpPr>
        <p:spPr>
          <a:xfrm>
            <a:off x="1528251" y="216264"/>
            <a:ext cx="6660405" cy="347136"/>
          </a:xfrm>
          <a:prstGeom prst="rect">
            <a:avLst/>
          </a:prstGeom>
          <a:solidFill>
            <a:schemeClr val="bg2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pt-BR" dirty="0">
                <a:solidFill>
                  <a:schemeClr val="tx1"/>
                </a:solidFill>
              </a:rPr>
              <a:t>Link: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F0D9A3BD-2B24-804B-0AAA-615E52F52D2E}"/>
              </a:ext>
            </a:extLst>
          </p:cNvPr>
          <p:cNvSpPr/>
          <p:nvPr/>
        </p:nvSpPr>
        <p:spPr>
          <a:xfrm>
            <a:off x="375674" y="29496"/>
            <a:ext cx="1179873" cy="648929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1"/>
                </a:solidFill>
                <a:effectLst/>
                <a:latin typeface="+mj-lt"/>
                <a:ea typeface="Aptos" panose="020B0004020202020204" pitchFamily="34" charset="0"/>
              </a:rPr>
              <a:t>STEP_</a:t>
            </a:r>
            <a:r>
              <a:rPr lang="pt-BR" b="1" dirty="0">
                <a:solidFill>
                  <a:schemeClr val="tx1"/>
                </a:solidFill>
                <a:latin typeface="+mj-lt"/>
              </a:rPr>
              <a:t>08</a:t>
            </a:r>
          </a:p>
        </p:txBody>
      </p:sp>
    </p:spTree>
    <p:extLst>
      <p:ext uri="{BB962C8B-B14F-4D97-AF65-F5344CB8AC3E}">
        <p14:creationId xmlns:p14="http://schemas.microsoft.com/office/powerpoint/2010/main" val="28523254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7</TotalTime>
  <Words>419</Words>
  <Application>Microsoft Office PowerPoint</Application>
  <PresentationFormat>Widescreen</PresentationFormat>
  <Paragraphs>73</Paragraphs>
  <Slides>12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2</vt:i4>
      </vt:variant>
    </vt:vector>
  </HeadingPairs>
  <TitlesOfParts>
    <vt:vector size="19" baseType="lpstr">
      <vt:lpstr>Aptos</vt:lpstr>
      <vt:lpstr>Aptos Display</vt:lpstr>
      <vt:lpstr>Aptos Narrow</vt:lpstr>
      <vt:lpstr>Arial</vt:lpstr>
      <vt:lpstr>Congenial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çois Isnaldo Dias Caldeira</dc:creator>
  <cp:lastModifiedBy>François Isnaldo Dias Caldeira</cp:lastModifiedBy>
  <cp:revision>24</cp:revision>
  <dcterms:created xsi:type="dcterms:W3CDTF">2025-01-09T14:48:16Z</dcterms:created>
  <dcterms:modified xsi:type="dcterms:W3CDTF">2025-02-07T20:04:18Z</dcterms:modified>
</cp:coreProperties>
</file>